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8423275" cy="6264275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973" userDrawn="1">
          <p15:clr>
            <a:srgbClr val="A4A3A4"/>
          </p15:clr>
        </p15:guide>
        <p15:guide id="2" pos="265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828" autoAdjust="0"/>
    <p:restoredTop sz="94660"/>
  </p:normalViewPr>
  <p:slideViewPr>
    <p:cSldViewPr snapToGrid="0" showGuides="1">
      <p:cViewPr varScale="1">
        <p:scale>
          <a:sx n="96" d="100"/>
          <a:sy n="96" d="100"/>
        </p:scale>
        <p:origin x="1734" y="96"/>
      </p:cViewPr>
      <p:guideLst>
        <p:guide orient="horz" pos="1973"/>
        <p:guide pos="265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31746" y="1025195"/>
            <a:ext cx="7159784" cy="2180896"/>
          </a:xfrm>
        </p:spPr>
        <p:txBody>
          <a:bodyPr anchor="b"/>
          <a:lstStyle>
            <a:lvl1pPr algn="ctr">
              <a:defRPr sz="548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52910" y="3290195"/>
            <a:ext cx="6317456" cy="1512416"/>
          </a:xfrm>
        </p:spPr>
        <p:txBody>
          <a:bodyPr/>
          <a:lstStyle>
            <a:lvl1pPr marL="0" indent="0" algn="ctr">
              <a:buNone/>
              <a:defRPr sz="2192"/>
            </a:lvl1pPr>
            <a:lvl2pPr marL="417606" indent="0" algn="ctr">
              <a:buNone/>
              <a:defRPr sz="1827"/>
            </a:lvl2pPr>
            <a:lvl3pPr marL="835213" indent="0" algn="ctr">
              <a:buNone/>
              <a:defRPr sz="1644"/>
            </a:lvl3pPr>
            <a:lvl4pPr marL="1252819" indent="0" algn="ctr">
              <a:buNone/>
              <a:defRPr sz="1461"/>
            </a:lvl4pPr>
            <a:lvl5pPr marL="1670426" indent="0" algn="ctr">
              <a:buNone/>
              <a:defRPr sz="1461"/>
            </a:lvl5pPr>
            <a:lvl6pPr marL="2088032" indent="0" algn="ctr">
              <a:buNone/>
              <a:defRPr sz="1461"/>
            </a:lvl6pPr>
            <a:lvl7pPr marL="2505639" indent="0" algn="ctr">
              <a:buNone/>
              <a:defRPr sz="1461"/>
            </a:lvl7pPr>
            <a:lvl8pPr marL="2923245" indent="0" algn="ctr">
              <a:buNone/>
              <a:defRPr sz="1461"/>
            </a:lvl8pPr>
            <a:lvl9pPr marL="3340852" indent="0" algn="ctr">
              <a:buNone/>
              <a:defRPr sz="1461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395667-C91C-4B64-81DB-831BACC6E8EE}" type="datetimeFigureOut">
              <a:rPr kumimoji="1" lang="ja-JP" altLang="en-US" smtClean="0"/>
              <a:t>2020/6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7B4E4-D7C1-4722-98C9-6248B1A013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8850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395667-C91C-4B64-81DB-831BACC6E8EE}" type="datetimeFigureOut">
              <a:rPr kumimoji="1" lang="ja-JP" altLang="en-US" smtClean="0"/>
              <a:t>2020/6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7B4E4-D7C1-4722-98C9-6248B1A013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325197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027906" y="333514"/>
            <a:ext cx="1816269" cy="5308684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79101" y="333514"/>
            <a:ext cx="5343515" cy="5308684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395667-C91C-4B64-81DB-831BACC6E8EE}" type="datetimeFigureOut">
              <a:rPr kumimoji="1" lang="ja-JP" altLang="en-US" smtClean="0"/>
              <a:t>2020/6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7B4E4-D7C1-4722-98C9-6248B1A013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0992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395667-C91C-4B64-81DB-831BACC6E8EE}" type="datetimeFigureOut">
              <a:rPr kumimoji="1" lang="ja-JP" altLang="en-US" smtClean="0"/>
              <a:t>2020/6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7B4E4-D7C1-4722-98C9-6248B1A013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07707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74713" y="1561720"/>
            <a:ext cx="7265075" cy="2605764"/>
          </a:xfrm>
        </p:spPr>
        <p:txBody>
          <a:bodyPr anchor="b"/>
          <a:lstStyle>
            <a:lvl1pPr>
              <a:defRPr sz="548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74713" y="4192136"/>
            <a:ext cx="7265075" cy="1370310"/>
          </a:xfrm>
        </p:spPr>
        <p:txBody>
          <a:bodyPr/>
          <a:lstStyle>
            <a:lvl1pPr marL="0" indent="0">
              <a:buNone/>
              <a:defRPr sz="2192">
                <a:solidFill>
                  <a:schemeClr val="tx1"/>
                </a:solidFill>
              </a:defRPr>
            </a:lvl1pPr>
            <a:lvl2pPr marL="417606" indent="0">
              <a:buNone/>
              <a:defRPr sz="1827">
                <a:solidFill>
                  <a:schemeClr val="tx1">
                    <a:tint val="75000"/>
                  </a:schemeClr>
                </a:solidFill>
              </a:defRPr>
            </a:lvl2pPr>
            <a:lvl3pPr marL="835213" indent="0">
              <a:buNone/>
              <a:defRPr sz="1644">
                <a:solidFill>
                  <a:schemeClr val="tx1">
                    <a:tint val="75000"/>
                  </a:schemeClr>
                </a:solidFill>
              </a:defRPr>
            </a:lvl3pPr>
            <a:lvl4pPr marL="1252819" indent="0">
              <a:buNone/>
              <a:defRPr sz="1461">
                <a:solidFill>
                  <a:schemeClr val="tx1">
                    <a:tint val="75000"/>
                  </a:schemeClr>
                </a:solidFill>
              </a:defRPr>
            </a:lvl4pPr>
            <a:lvl5pPr marL="1670426" indent="0">
              <a:buNone/>
              <a:defRPr sz="1461">
                <a:solidFill>
                  <a:schemeClr val="tx1">
                    <a:tint val="75000"/>
                  </a:schemeClr>
                </a:solidFill>
              </a:defRPr>
            </a:lvl5pPr>
            <a:lvl6pPr marL="2088032" indent="0">
              <a:buNone/>
              <a:defRPr sz="1461">
                <a:solidFill>
                  <a:schemeClr val="tx1">
                    <a:tint val="75000"/>
                  </a:schemeClr>
                </a:solidFill>
              </a:defRPr>
            </a:lvl6pPr>
            <a:lvl7pPr marL="2505639" indent="0">
              <a:buNone/>
              <a:defRPr sz="1461">
                <a:solidFill>
                  <a:schemeClr val="tx1">
                    <a:tint val="75000"/>
                  </a:schemeClr>
                </a:solidFill>
              </a:defRPr>
            </a:lvl7pPr>
            <a:lvl8pPr marL="2923245" indent="0">
              <a:buNone/>
              <a:defRPr sz="1461">
                <a:solidFill>
                  <a:schemeClr val="tx1">
                    <a:tint val="75000"/>
                  </a:schemeClr>
                </a:solidFill>
              </a:defRPr>
            </a:lvl8pPr>
            <a:lvl9pPr marL="3340852" indent="0">
              <a:buNone/>
              <a:defRPr sz="146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395667-C91C-4B64-81DB-831BACC6E8EE}" type="datetimeFigureOut">
              <a:rPr kumimoji="1" lang="ja-JP" altLang="en-US" smtClean="0"/>
              <a:t>2020/6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7B4E4-D7C1-4722-98C9-6248B1A013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27798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79100" y="1667573"/>
            <a:ext cx="3579892" cy="3974625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264283" y="1667573"/>
            <a:ext cx="3579892" cy="3974625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395667-C91C-4B64-81DB-831BACC6E8EE}" type="datetimeFigureOut">
              <a:rPr kumimoji="1" lang="ja-JP" altLang="en-US" smtClean="0"/>
              <a:t>2020/6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7B4E4-D7C1-4722-98C9-6248B1A013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303678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80197" y="333516"/>
            <a:ext cx="7265075" cy="1210804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80198" y="1535618"/>
            <a:ext cx="3563440" cy="752583"/>
          </a:xfrm>
        </p:spPr>
        <p:txBody>
          <a:bodyPr anchor="b"/>
          <a:lstStyle>
            <a:lvl1pPr marL="0" indent="0">
              <a:buNone/>
              <a:defRPr sz="2192" b="1"/>
            </a:lvl1pPr>
            <a:lvl2pPr marL="417606" indent="0">
              <a:buNone/>
              <a:defRPr sz="1827" b="1"/>
            </a:lvl2pPr>
            <a:lvl3pPr marL="835213" indent="0">
              <a:buNone/>
              <a:defRPr sz="1644" b="1"/>
            </a:lvl3pPr>
            <a:lvl4pPr marL="1252819" indent="0">
              <a:buNone/>
              <a:defRPr sz="1461" b="1"/>
            </a:lvl4pPr>
            <a:lvl5pPr marL="1670426" indent="0">
              <a:buNone/>
              <a:defRPr sz="1461" b="1"/>
            </a:lvl5pPr>
            <a:lvl6pPr marL="2088032" indent="0">
              <a:buNone/>
              <a:defRPr sz="1461" b="1"/>
            </a:lvl6pPr>
            <a:lvl7pPr marL="2505639" indent="0">
              <a:buNone/>
              <a:defRPr sz="1461" b="1"/>
            </a:lvl7pPr>
            <a:lvl8pPr marL="2923245" indent="0">
              <a:buNone/>
              <a:defRPr sz="1461" b="1"/>
            </a:lvl8pPr>
            <a:lvl9pPr marL="3340852" indent="0">
              <a:buNone/>
              <a:defRPr sz="1461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80198" y="2288201"/>
            <a:ext cx="3563440" cy="336559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264283" y="1535618"/>
            <a:ext cx="3580989" cy="752583"/>
          </a:xfrm>
        </p:spPr>
        <p:txBody>
          <a:bodyPr anchor="b"/>
          <a:lstStyle>
            <a:lvl1pPr marL="0" indent="0">
              <a:buNone/>
              <a:defRPr sz="2192" b="1"/>
            </a:lvl1pPr>
            <a:lvl2pPr marL="417606" indent="0">
              <a:buNone/>
              <a:defRPr sz="1827" b="1"/>
            </a:lvl2pPr>
            <a:lvl3pPr marL="835213" indent="0">
              <a:buNone/>
              <a:defRPr sz="1644" b="1"/>
            </a:lvl3pPr>
            <a:lvl4pPr marL="1252819" indent="0">
              <a:buNone/>
              <a:defRPr sz="1461" b="1"/>
            </a:lvl4pPr>
            <a:lvl5pPr marL="1670426" indent="0">
              <a:buNone/>
              <a:defRPr sz="1461" b="1"/>
            </a:lvl5pPr>
            <a:lvl6pPr marL="2088032" indent="0">
              <a:buNone/>
              <a:defRPr sz="1461" b="1"/>
            </a:lvl6pPr>
            <a:lvl7pPr marL="2505639" indent="0">
              <a:buNone/>
              <a:defRPr sz="1461" b="1"/>
            </a:lvl7pPr>
            <a:lvl8pPr marL="2923245" indent="0">
              <a:buNone/>
              <a:defRPr sz="1461" b="1"/>
            </a:lvl8pPr>
            <a:lvl9pPr marL="3340852" indent="0">
              <a:buNone/>
              <a:defRPr sz="1461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264283" y="2288201"/>
            <a:ext cx="3580989" cy="336559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395667-C91C-4B64-81DB-831BACC6E8EE}" type="datetimeFigureOut">
              <a:rPr kumimoji="1" lang="ja-JP" altLang="en-US" smtClean="0"/>
              <a:t>2020/6/2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7B4E4-D7C1-4722-98C9-6248B1A013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076914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395667-C91C-4B64-81DB-831BACC6E8EE}" type="datetimeFigureOut">
              <a:rPr kumimoji="1" lang="ja-JP" altLang="en-US" smtClean="0"/>
              <a:t>2020/6/2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7B4E4-D7C1-4722-98C9-6248B1A013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83127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395667-C91C-4B64-81DB-831BACC6E8EE}" type="datetimeFigureOut">
              <a:rPr kumimoji="1" lang="ja-JP" altLang="en-US" smtClean="0"/>
              <a:t>2020/6/2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7B4E4-D7C1-4722-98C9-6248B1A013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259542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80197" y="417618"/>
            <a:ext cx="2716725" cy="1461664"/>
          </a:xfrm>
        </p:spPr>
        <p:txBody>
          <a:bodyPr anchor="b"/>
          <a:lstStyle>
            <a:lvl1pPr>
              <a:defRPr sz="2923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80989" y="901941"/>
            <a:ext cx="4264283" cy="4451695"/>
          </a:xfrm>
        </p:spPr>
        <p:txBody>
          <a:bodyPr/>
          <a:lstStyle>
            <a:lvl1pPr>
              <a:defRPr sz="2923"/>
            </a:lvl1pPr>
            <a:lvl2pPr>
              <a:defRPr sz="2558"/>
            </a:lvl2pPr>
            <a:lvl3pPr>
              <a:defRPr sz="2192"/>
            </a:lvl3pPr>
            <a:lvl4pPr>
              <a:defRPr sz="1827"/>
            </a:lvl4pPr>
            <a:lvl5pPr>
              <a:defRPr sz="1827"/>
            </a:lvl5pPr>
            <a:lvl6pPr>
              <a:defRPr sz="1827"/>
            </a:lvl6pPr>
            <a:lvl7pPr>
              <a:defRPr sz="1827"/>
            </a:lvl7pPr>
            <a:lvl8pPr>
              <a:defRPr sz="1827"/>
            </a:lvl8pPr>
            <a:lvl9pPr>
              <a:defRPr sz="1827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80197" y="1879283"/>
            <a:ext cx="2716725" cy="3481603"/>
          </a:xfrm>
        </p:spPr>
        <p:txBody>
          <a:bodyPr/>
          <a:lstStyle>
            <a:lvl1pPr marL="0" indent="0">
              <a:buNone/>
              <a:defRPr sz="1461"/>
            </a:lvl1pPr>
            <a:lvl2pPr marL="417606" indent="0">
              <a:buNone/>
              <a:defRPr sz="1279"/>
            </a:lvl2pPr>
            <a:lvl3pPr marL="835213" indent="0">
              <a:buNone/>
              <a:defRPr sz="1096"/>
            </a:lvl3pPr>
            <a:lvl4pPr marL="1252819" indent="0">
              <a:buNone/>
              <a:defRPr sz="913"/>
            </a:lvl4pPr>
            <a:lvl5pPr marL="1670426" indent="0">
              <a:buNone/>
              <a:defRPr sz="913"/>
            </a:lvl5pPr>
            <a:lvl6pPr marL="2088032" indent="0">
              <a:buNone/>
              <a:defRPr sz="913"/>
            </a:lvl6pPr>
            <a:lvl7pPr marL="2505639" indent="0">
              <a:buNone/>
              <a:defRPr sz="913"/>
            </a:lvl7pPr>
            <a:lvl8pPr marL="2923245" indent="0">
              <a:buNone/>
              <a:defRPr sz="913"/>
            </a:lvl8pPr>
            <a:lvl9pPr marL="3340852" indent="0">
              <a:buNone/>
              <a:defRPr sz="913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395667-C91C-4B64-81DB-831BACC6E8EE}" type="datetimeFigureOut">
              <a:rPr kumimoji="1" lang="ja-JP" altLang="en-US" smtClean="0"/>
              <a:t>2020/6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7B4E4-D7C1-4722-98C9-6248B1A013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05981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80197" y="417618"/>
            <a:ext cx="2716725" cy="1461664"/>
          </a:xfrm>
        </p:spPr>
        <p:txBody>
          <a:bodyPr anchor="b"/>
          <a:lstStyle>
            <a:lvl1pPr>
              <a:defRPr sz="2923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580989" y="901941"/>
            <a:ext cx="4264283" cy="4451695"/>
          </a:xfrm>
        </p:spPr>
        <p:txBody>
          <a:bodyPr anchor="t"/>
          <a:lstStyle>
            <a:lvl1pPr marL="0" indent="0">
              <a:buNone/>
              <a:defRPr sz="2923"/>
            </a:lvl1pPr>
            <a:lvl2pPr marL="417606" indent="0">
              <a:buNone/>
              <a:defRPr sz="2558"/>
            </a:lvl2pPr>
            <a:lvl3pPr marL="835213" indent="0">
              <a:buNone/>
              <a:defRPr sz="2192"/>
            </a:lvl3pPr>
            <a:lvl4pPr marL="1252819" indent="0">
              <a:buNone/>
              <a:defRPr sz="1827"/>
            </a:lvl4pPr>
            <a:lvl5pPr marL="1670426" indent="0">
              <a:buNone/>
              <a:defRPr sz="1827"/>
            </a:lvl5pPr>
            <a:lvl6pPr marL="2088032" indent="0">
              <a:buNone/>
              <a:defRPr sz="1827"/>
            </a:lvl6pPr>
            <a:lvl7pPr marL="2505639" indent="0">
              <a:buNone/>
              <a:defRPr sz="1827"/>
            </a:lvl7pPr>
            <a:lvl8pPr marL="2923245" indent="0">
              <a:buNone/>
              <a:defRPr sz="1827"/>
            </a:lvl8pPr>
            <a:lvl9pPr marL="3340852" indent="0">
              <a:buNone/>
              <a:defRPr sz="1827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80197" y="1879283"/>
            <a:ext cx="2716725" cy="3481603"/>
          </a:xfrm>
        </p:spPr>
        <p:txBody>
          <a:bodyPr/>
          <a:lstStyle>
            <a:lvl1pPr marL="0" indent="0">
              <a:buNone/>
              <a:defRPr sz="1461"/>
            </a:lvl1pPr>
            <a:lvl2pPr marL="417606" indent="0">
              <a:buNone/>
              <a:defRPr sz="1279"/>
            </a:lvl2pPr>
            <a:lvl3pPr marL="835213" indent="0">
              <a:buNone/>
              <a:defRPr sz="1096"/>
            </a:lvl3pPr>
            <a:lvl4pPr marL="1252819" indent="0">
              <a:buNone/>
              <a:defRPr sz="913"/>
            </a:lvl4pPr>
            <a:lvl5pPr marL="1670426" indent="0">
              <a:buNone/>
              <a:defRPr sz="913"/>
            </a:lvl5pPr>
            <a:lvl6pPr marL="2088032" indent="0">
              <a:buNone/>
              <a:defRPr sz="913"/>
            </a:lvl6pPr>
            <a:lvl7pPr marL="2505639" indent="0">
              <a:buNone/>
              <a:defRPr sz="913"/>
            </a:lvl7pPr>
            <a:lvl8pPr marL="2923245" indent="0">
              <a:buNone/>
              <a:defRPr sz="913"/>
            </a:lvl8pPr>
            <a:lvl9pPr marL="3340852" indent="0">
              <a:buNone/>
              <a:defRPr sz="913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395667-C91C-4B64-81DB-831BACC6E8EE}" type="datetimeFigureOut">
              <a:rPr kumimoji="1" lang="ja-JP" altLang="en-US" smtClean="0"/>
              <a:t>2020/6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77B4E4-D7C1-4722-98C9-6248B1A013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703995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79100" y="333516"/>
            <a:ext cx="7265075" cy="121080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79100" y="1667573"/>
            <a:ext cx="7265075" cy="397462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79100" y="5806056"/>
            <a:ext cx="1895237" cy="33351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9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395667-C91C-4B64-81DB-831BACC6E8EE}" type="datetimeFigureOut">
              <a:rPr kumimoji="1" lang="ja-JP" altLang="en-US" smtClean="0"/>
              <a:t>2020/6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790210" y="5806056"/>
            <a:ext cx="2842855" cy="33351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9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948938" y="5806056"/>
            <a:ext cx="1895237" cy="33351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9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77B4E4-D7C1-4722-98C9-6248B1A0133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48745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835213" rtl="0" eaLnBrk="1" latinLnBrk="0" hangingPunct="1">
        <a:lnSpc>
          <a:spcPct val="90000"/>
        </a:lnSpc>
        <a:spcBef>
          <a:spcPct val="0"/>
        </a:spcBef>
        <a:buNone/>
        <a:defRPr kumimoji="1" sz="401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08803" indent="-208803" algn="l" defTabSz="835213" rtl="0" eaLnBrk="1" latinLnBrk="0" hangingPunct="1">
        <a:lnSpc>
          <a:spcPct val="90000"/>
        </a:lnSpc>
        <a:spcBef>
          <a:spcPts val="913"/>
        </a:spcBef>
        <a:buFont typeface="Arial" panose="020B0604020202020204" pitchFamily="34" charset="0"/>
        <a:buChar char="•"/>
        <a:defRPr kumimoji="1" sz="2558" kern="1200">
          <a:solidFill>
            <a:schemeClr val="tx1"/>
          </a:solidFill>
          <a:latin typeface="+mn-lt"/>
          <a:ea typeface="+mn-ea"/>
          <a:cs typeface="+mn-cs"/>
        </a:defRPr>
      </a:lvl1pPr>
      <a:lvl2pPr marL="626410" indent="-208803" algn="l" defTabSz="835213" rtl="0" eaLnBrk="1" latinLnBrk="0" hangingPunct="1">
        <a:lnSpc>
          <a:spcPct val="90000"/>
        </a:lnSpc>
        <a:spcBef>
          <a:spcPts val="457"/>
        </a:spcBef>
        <a:buFont typeface="Arial" panose="020B0604020202020204" pitchFamily="34" charset="0"/>
        <a:buChar char="•"/>
        <a:defRPr kumimoji="1" sz="2192" kern="1200">
          <a:solidFill>
            <a:schemeClr val="tx1"/>
          </a:solidFill>
          <a:latin typeface="+mn-lt"/>
          <a:ea typeface="+mn-ea"/>
          <a:cs typeface="+mn-cs"/>
        </a:defRPr>
      </a:lvl2pPr>
      <a:lvl3pPr marL="1044016" indent="-208803" algn="l" defTabSz="835213" rtl="0" eaLnBrk="1" latinLnBrk="0" hangingPunct="1">
        <a:lnSpc>
          <a:spcPct val="90000"/>
        </a:lnSpc>
        <a:spcBef>
          <a:spcPts val="457"/>
        </a:spcBef>
        <a:buFont typeface="Arial" panose="020B0604020202020204" pitchFamily="34" charset="0"/>
        <a:buChar char="•"/>
        <a:defRPr kumimoji="1" sz="1827" kern="1200">
          <a:solidFill>
            <a:schemeClr val="tx1"/>
          </a:solidFill>
          <a:latin typeface="+mn-lt"/>
          <a:ea typeface="+mn-ea"/>
          <a:cs typeface="+mn-cs"/>
        </a:defRPr>
      </a:lvl3pPr>
      <a:lvl4pPr marL="1461623" indent="-208803" algn="l" defTabSz="835213" rtl="0" eaLnBrk="1" latinLnBrk="0" hangingPunct="1">
        <a:lnSpc>
          <a:spcPct val="90000"/>
        </a:lnSpc>
        <a:spcBef>
          <a:spcPts val="457"/>
        </a:spcBef>
        <a:buFont typeface="Arial" panose="020B0604020202020204" pitchFamily="34" charset="0"/>
        <a:buChar char="•"/>
        <a:defRPr kumimoji="1" sz="1644" kern="1200">
          <a:solidFill>
            <a:schemeClr val="tx1"/>
          </a:solidFill>
          <a:latin typeface="+mn-lt"/>
          <a:ea typeface="+mn-ea"/>
          <a:cs typeface="+mn-cs"/>
        </a:defRPr>
      </a:lvl4pPr>
      <a:lvl5pPr marL="1879229" indent="-208803" algn="l" defTabSz="835213" rtl="0" eaLnBrk="1" latinLnBrk="0" hangingPunct="1">
        <a:lnSpc>
          <a:spcPct val="90000"/>
        </a:lnSpc>
        <a:spcBef>
          <a:spcPts val="457"/>
        </a:spcBef>
        <a:buFont typeface="Arial" panose="020B0604020202020204" pitchFamily="34" charset="0"/>
        <a:buChar char="•"/>
        <a:defRPr kumimoji="1" sz="1644" kern="1200">
          <a:solidFill>
            <a:schemeClr val="tx1"/>
          </a:solidFill>
          <a:latin typeface="+mn-lt"/>
          <a:ea typeface="+mn-ea"/>
          <a:cs typeface="+mn-cs"/>
        </a:defRPr>
      </a:lvl5pPr>
      <a:lvl6pPr marL="2296836" indent="-208803" algn="l" defTabSz="835213" rtl="0" eaLnBrk="1" latinLnBrk="0" hangingPunct="1">
        <a:lnSpc>
          <a:spcPct val="90000"/>
        </a:lnSpc>
        <a:spcBef>
          <a:spcPts val="457"/>
        </a:spcBef>
        <a:buFont typeface="Arial" panose="020B0604020202020204" pitchFamily="34" charset="0"/>
        <a:buChar char="•"/>
        <a:defRPr kumimoji="1" sz="1644" kern="1200">
          <a:solidFill>
            <a:schemeClr val="tx1"/>
          </a:solidFill>
          <a:latin typeface="+mn-lt"/>
          <a:ea typeface="+mn-ea"/>
          <a:cs typeface="+mn-cs"/>
        </a:defRPr>
      </a:lvl6pPr>
      <a:lvl7pPr marL="2714442" indent="-208803" algn="l" defTabSz="835213" rtl="0" eaLnBrk="1" latinLnBrk="0" hangingPunct="1">
        <a:lnSpc>
          <a:spcPct val="90000"/>
        </a:lnSpc>
        <a:spcBef>
          <a:spcPts val="457"/>
        </a:spcBef>
        <a:buFont typeface="Arial" panose="020B0604020202020204" pitchFamily="34" charset="0"/>
        <a:buChar char="•"/>
        <a:defRPr kumimoji="1" sz="1644" kern="1200">
          <a:solidFill>
            <a:schemeClr val="tx1"/>
          </a:solidFill>
          <a:latin typeface="+mn-lt"/>
          <a:ea typeface="+mn-ea"/>
          <a:cs typeface="+mn-cs"/>
        </a:defRPr>
      </a:lvl7pPr>
      <a:lvl8pPr marL="3132049" indent="-208803" algn="l" defTabSz="835213" rtl="0" eaLnBrk="1" latinLnBrk="0" hangingPunct="1">
        <a:lnSpc>
          <a:spcPct val="90000"/>
        </a:lnSpc>
        <a:spcBef>
          <a:spcPts val="457"/>
        </a:spcBef>
        <a:buFont typeface="Arial" panose="020B0604020202020204" pitchFamily="34" charset="0"/>
        <a:buChar char="•"/>
        <a:defRPr kumimoji="1" sz="1644" kern="1200">
          <a:solidFill>
            <a:schemeClr val="tx1"/>
          </a:solidFill>
          <a:latin typeface="+mn-lt"/>
          <a:ea typeface="+mn-ea"/>
          <a:cs typeface="+mn-cs"/>
        </a:defRPr>
      </a:lvl8pPr>
      <a:lvl9pPr marL="3549655" indent="-208803" algn="l" defTabSz="835213" rtl="0" eaLnBrk="1" latinLnBrk="0" hangingPunct="1">
        <a:lnSpc>
          <a:spcPct val="90000"/>
        </a:lnSpc>
        <a:spcBef>
          <a:spcPts val="457"/>
        </a:spcBef>
        <a:buFont typeface="Arial" panose="020B0604020202020204" pitchFamily="34" charset="0"/>
        <a:buChar char="•"/>
        <a:defRPr kumimoji="1" sz="164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35213" rtl="0" eaLnBrk="1" latinLnBrk="0" hangingPunct="1">
        <a:defRPr kumimoji="1" sz="1644" kern="1200">
          <a:solidFill>
            <a:schemeClr val="tx1"/>
          </a:solidFill>
          <a:latin typeface="+mn-lt"/>
          <a:ea typeface="+mn-ea"/>
          <a:cs typeface="+mn-cs"/>
        </a:defRPr>
      </a:lvl1pPr>
      <a:lvl2pPr marL="417606" algn="l" defTabSz="835213" rtl="0" eaLnBrk="1" latinLnBrk="0" hangingPunct="1">
        <a:defRPr kumimoji="1" sz="1644" kern="1200">
          <a:solidFill>
            <a:schemeClr val="tx1"/>
          </a:solidFill>
          <a:latin typeface="+mn-lt"/>
          <a:ea typeface="+mn-ea"/>
          <a:cs typeface="+mn-cs"/>
        </a:defRPr>
      </a:lvl2pPr>
      <a:lvl3pPr marL="835213" algn="l" defTabSz="835213" rtl="0" eaLnBrk="1" latinLnBrk="0" hangingPunct="1">
        <a:defRPr kumimoji="1" sz="1644" kern="1200">
          <a:solidFill>
            <a:schemeClr val="tx1"/>
          </a:solidFill>
          <a:latin typeface="+mn-lt"/>
          <a:ea typeface="+mn-ea"/>
          <a:cs typeface="+mn-cs"/>
        </a:defRPr>
      </a:lvl3pPr>
      <a:lvl4pPr marL="1252819" algn="l" defTabSz="835213" rtl="0" eaLnBrk="1" latinLnBrk="0" hangingPunct="1">
        <a:defRPr kumimoji="1" sz="1644" kern="1200">
          <a:solidFill>
            <a:schemeClr val="tx1"/>
          </a:solidFill>
          <a:latin typeface="+mn-lt"/>
          <a:ea typeface="+mn-ea"/>
          <a:cs typeface="+mn-cs"/>
        </a:defRPr>
      </a:lvl4pPr>
      <a:lvl5pPr marL="1670426" algn="l" defTabSz="835213" rtl="0" eaLnBrk="1" latinLnBrk="0" hangingPunct="1">
        <a:defRPr kumimoji="1" sz="1644" kern="1200">
          <a:solidFill>
            <a:schemeClr val="tx1"/>
          </a:solidFill>
          <a:latin typeface="+mn-lt"/>
          <a:ea typeface="+mn-ea"/>
          <a:cs typeface="+mn-cs"/>
        </a:defRPr>
      </a:lvl5pPr>
      <a:lvl6pPr marL="2088032" algn="l" defTabSz="835213" rtl="0" eaLnBrk="1" latinLnBrk="0" hangingPunct="1">
        <a:defRPr kumimoji="1" sz="1644" kern="1200">
          <a:solidFill>
            <a:schemeClr val="tx1"/>
          </a:solidFill>
          <a:latin typeface="+mn-lt"/>
          <a:ea typeface="+mn-ea"/>
          <a:cs typeface="+mn-cs"/>
        </a:defRPr>
      </a:lvl6pPr>
      <a:lvl7pPr marL="2505639" algn="l" defTabSz="835213" rtl="0" eaLnBrk="1" latinLnBrk="0" hangingPunct="1">
        <a:defRPr kumimoji="1" sz="1644" kern="1200">
          <a:solidFill>
            <a:schemeClr val="tx1"/>
          </a:solidFill>
          <a:latin typeface="+mn-lt"/>
          <a:ea typeface="+mn-ea"/>
          <a:cs typeface="+mn-cs"/>
        </a:defRPr>
      </a:lvl7pPr>
      <a:lvl8pPr marL="2923245" algn="l" defTabSz="835213" rtl="0" eaLnBrk="1" latinLnBrk="0" hangingPunct="1">
        <a:defRPr kumimoji="1" sz="1644" kern="1200">
          <a:solidFill>
            <a:schemeClr val="tx1"/>
          </a:solidFill>
          <a:latin typeface="+mn-lt"/>
          <a:ea typeface="+mn-ea"/>
          <a:cs typeface="+mn-cs"/>
        </a:defRPr>
      </a:lvl8pPr>
      <a:lvl9pPr marL="3340852" algn="l" defTabSz="835213" rtl="0" eaLnBrk="1" latinLnBrk="0" hangingPunct="1">
        <a:defRPr kumimoji="1" sz="164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図 17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19551" y="4209426"/>
            <a:ext cx="1152000" cy="1152000"/>
          </a:xfrm>
          <a:prstGeom prst="rect">
            <a:avLst/>
          </a:prstGeom>
        </p:spPr>
      </p:pic>
      <p:pic>
        <p:nvPicPr>
          <p:cNvPr id="17" name="図 1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97449" y="4204358"/>
            <a:ext cx="1152000" cy="1152000"/>
          </a:xfrm>
          <a:prstGeom prst="rect">
            <a:avLst/>
          </a:prstGeom>
        </p:spPr>
      </p:pic>
      <p:pic>
        <p:nvPicPr>
          <p:cNvPr id="16" name="図 1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27927" y="4193984"/>
            <a:ext cx="1152000" cy="1152000"/>
          </a:xfrm>
          <a:prstGeom prst="rect">
            <a:avLst/>
          </a:prstGeom>
        </p:spPr>
      </p:pic>
      <p:pic>
        <p:nvPicPr>
          <p:cNvPr id="3" name="図 2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8604" y="1097227"/>
            <a:ext cx="1152000" cy="1152000"/>
          </a:xfrm>
          <a:prstGeom prst="rect">
            <a:avLst/>
          </a:prstGeom>
        </p:spPr>
      </p:pic>
      <p:pic>
        <p:nvPicPr>
          <p:cNvPr id="2" name="図 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195294" y="2642996"/>
            <a:ext cx="1152000" cy="1152000"/>
          </a:xfrm>
          <a:prstGeom prst="rect">
            <a:avLst/>
          </a:prstGeom>
        </p:spPr>
      </p:pic>
      <p:sp>
        <p:nvSpPr>
          <p:cNvPr id="10" name="テキスト ボックス 9"/>
          <p:cNvSpPr txBox="1"/>
          <p:nvPr/>
        </p:nvSpPr>
        <p:spPr>
          <a:xfrm>
            <a:off x="1060746" y="779498"/>
            <a:ext cx="6399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STMGP</a:t>
            </a:r>
            <a:endParaRPr lang="ja-JP" altLang="en-US" sz="10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2587878" y="779498"/>
            <a:ext cx="4475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PRS</a:t>
            </a:r>
            <a:endParaRPr lang="ja-JP" altLang="en-US" sz="10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3687687" y="779498"/>
            <a:ext cx="61747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GBLUP</a:t>
            </a:r>
            <a:endParaRPr lang="ja-JP" altLang="en-US" sz="10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4876860" y="779498"/>
            <a:ext cx="6030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SBLUP</a:t>
            </a: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6321261" y="779498"/>
            <a:ext cx="6319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 err="1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BayesR</a:t>
            </a:r>
            <a:endParaRPr lang="ja-JP" altLang="en-US" sz="10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7658599" y="779498"/>
            <a:ext cx="5180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Ridge</a:t>
            </a:r>
            <a:endParaRPr lang="ja-JP" altLang="en-US" sz="10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pic>
        <p:nvPicPr>
          <p:cNvPr id="9" name="図 8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9770" y="4204358"/>
            <a:ext cx="1152001" cy="1152000"/>
          </a:xfrm>
          <a:prstGeom prst="rect">
            <a:avLst/>
          </a:prstGeom>
        </p:spPr>
      </p:pic>
      <p:pic>
        <p:nvPicPr>
          <p:cNvPr id="7" name="図 6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39907" y="4204358"/>
            <a:ext cx="1151997" cy="1152000"/>
          </a:xfrm>
          <a:prstGeom prst="rect">
            <a:avLst/>
          </a:prstGeom>
        </p:spPr>
      </p:pic>
      <p:pic>
        <p:nvPicPr>
          <p:cNvPr id="4" name="図 3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09925" y="4204358"/>
            <a:ext cx="1152003" cy="1152000"/>
          </a:xfrm>
          <a:prstGeom prst="rect">
            <a:avLst/>
          </a:prstGeom>
        </p:spPr>
      </p:pic>
      <p:sp>
        <p:nvSpPr>
          <p:cNvPr id="42" name="テキスト ボックス 41"/>
          <p:cNvSpPr txBox="1"/>
          <p:nvPr/>
        </p:nvSpPr>
        <p:spPr>
          <a:xfrm>
            <a:off x="1417726" y="1097227"/>
            <a:ext cx="5501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900" dirty="0" smtClean="0">
                <a:solidFill>
                  <a:srgbClr val="1414FE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0.591</a:t>
            </a:r>
          </a:p>
          <a:p>
            <a:pPr algn="ctr"/>
            <a:r>
              <a:rPr lang="en-US" altLang="ja-JP" sz="900" dirty="0" smtClean="0">
                <a:solidFill>
                  <a:srgbClr val="1414FE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(0.137)</a:t>
            </a:r>
            <a:endParaRPr lang="ja-JP" altLang="en-US" sz="900" dirty="0">
              <a:solidFill>
                <a:srgbClr val="1414FE"/>
              </a:solidFill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pic>
        <p:nvPicPr>
          <p:cNvPr id="44" name="図 43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32863" y="1099561"/>
            <a:ext cx="1152000" cy="1152000"/>
          </a:xfrm>
          <a:prstGeom prst="rect">
            <a:avLst/>
          </a:prstGeom>
        </p:spPr>
      </p:pic>
      <p:sp>
        <p:nvSpPr>
          <p:cNvPr id="45" name="テキスト ボックス 44"/>
          <p:cNvSpPr txBox="1"/>
          <p:nvPr/>
        </p:nvSpPr>
        <p:spPr>
          <a:xfrm>
            <a:off x="2753107" y="1320700"/>
            <a:ext cx="5501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900" dirty="0" smtClean="0">
                <a:solidFill>
                  <a:srgbClr val="1414FE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0.100</a:t>
            </a:r>
            <a:endParaRPr lang="en-US" altLang="ja-JP" sz="900" dirty="0">
              <a:solidFill>
                <a:srgbClr val="1414FE"/>
              </a:solidFill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  <a:p>
            <a:pPr algn="ctr"/>
            <a:r>
              <a:rPr lang="en-US" altLang="ja-JP" sz="900" dirty="0">
                <a:solidFill>
                  <a:srgbClr val="1414FE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(0.055)</a:t>
            </a:r>
          </a:p>
        </p:txBody>
      </p:sp>
      <p:pic>
        <p:nvPicPr>
          <p:cNvPr id="47" name="図 46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44840" y="1099561"/>
            <a:ext cx="1152000" cy="1152000"/>
          </a:xfrm>
          <a:prstGeom prst="rect">
            <a:avLst/>
          </a:prstGeom>
        </p:spPr>
      </p:pic>
      <p:sp>
        <p:nvSpPr>
          <p:cNvPr id="48" name="テキスト ボックス 47"/>
          <p:cNvSpPr txBox="1"/>
          <p:nvPr/>
        </p:nvSpPr>
        <p:spPr>
          <a:xfrm>
            <a:off x="4008886" y="1332659"/>
            <a:ext cx="5501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900" dirty="0">
                <a:solidFill>
                  <a:srgbClr val="1414FE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0.097</a:t>
            </a:r>
          </a:p>
          <a:p>
            <a:pPr algn="ctr"/>
            <a:r>
              <a:rPr lang="en-US" altLang="ja-JP" sz="900" dirty="0">
                <a:solidFill>
                  <a:srgbClr val="1414FE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(0.055</a:t>
            </a:r>
            <a:r>
              <a:rPr lang="en-US" altLang="ja-JP" sz="900" dirty="0" smtClean="0">
                <a:solidFill>
                  <a:srgbClr val="1414FE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)</a:t>
            </a:r>
            <a:endParaRPr lang="en-US" altLang="ja-JP" sz="900" dirty="0">
              <a:solidFill>
                <a:srgbClr val="1414FE"/>
              </a:solidFill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pic>
        <p:nvPicPr>
          <p:cNvPr id="50" name="図 49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02385" y="1099561"/>
            <a:ext cx="1152000" cy="1152000"/>
          </a:xfrm>
          <a:prstGeom prst="rect">
            <a:avLst/>
          </a:prstGeom>
        </p:spPr>
      </p:pic>
      <p:pic>
        <p:nvPicPr>
          <p:cNvPr id="53" name="図 52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32620" y="1099561"/>
            <a:ext cx="1152003" cy="1152000"/>
          </a:xfrm>
          <a:prstGeom prst="rect">
            <a:avLst/>
          </a:prstGeom>
        </p:spPr>
      </p:pic>
      <p:pic>
        <p:nvPicPr>
          <p:cNvPr id="56" name="図 55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95294" y="1099561"/>
            <a:ext cx="1152000" cy="1152000"/>
          </a:xfrm>
          <a:prstGeom prst="rect">
            <a:avLst/>
          </a:prstGeom>
        </p:spPr>
      </p:pic>
      <p:pic>
        <p:nvPicPr>
          <p:cNvPr id="59" name="図 58"/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4707" y="2642996"/>
            <a:ext cx="1152000" cy="1152000"/>
          </a:xfrm>
          <a:prstGeom prst="rect">
            <a:avLst/>
          </a:prstGeom>
        </p:spPr>
      </p:pic>
      <p:pic>
        <p:nvPicPr>
          <p:cNvPr id="62" name="図 61"/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32866" y="2642996"/>
            <a:ext cx="1151997" cy="1152000"/>
          </a:xfrm>
          <a:prstGeom prst="rect">
            <a:avLst/>
          </a:prstGeom>
        </p:spPr>
      </p:pic>
      <p:pic>
        <p:nvPicPr>
          <p:cNvPr id="65" name="図 64"/>
          <p:cNvPicPr>
            <a:picLocks noChangeAspect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44838" y="2642996"/>
            <a:ext cx="1152002" cy="1152000"/>
          </a:xfrm>
          <a:prstGeom prst="rect">
            <a:avLst/>
          </a:prstGeom>
        </p:spPr>
      </p:pic>
      <p:pic>
        <p:nvPicPr>
          <p:cNvPr id="68" name="図 67"/>
          <p:cNvPicPr>
            <a:picLocks noChangeAspect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02385" y="2642996"/>
            <a:ext cx="1152000" cy="1152000"/>
          </a:xfrm>
          <a:prstGeom prst="rect">
            <a:avLst/>
          </a:prstGeom>
        </p:spPr>
      </p:pic>
      <p:pic>
        <p:nvPicPr>
          <p:cNvPr id="71" name="図 70"/>
          <p:cNvPicPr>
            <a:picLocks noChangeAspect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27788" y="2642996"/>
            <a:ext cx="1152003" cy="1152000"/>
          </a:xfrm>
          <a:prstGeom prst="rect">
            <a:avLst/>
          </a:prstGeom>
        </p:spPr>
      </p:pic>
      <p:sp>
        <p:nvSpPr>
          <p:cNvPr id="76" name="テキスト ボックス 75"/>
          <p:cNvSpPr txBox="1"/>
          <p:nvPr/>
        </p:nvSpPr>
        <p:spPr>
          <a:xfrm>
            <a:off x="11032" y="1336433"/>
            <a:ext cx="7681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Test</a:t>
            </a:r>
          </a:p>
          <a:p>
            <a:r>
              <a:rPr lang="en-US" altLang="ja-JP" sz="9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All subjects</a:t>
            </a:r>
            <a:endParaRPr lang="ja-JP" altLang="en-US" sz="9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77" name="テキスト ボックス 76"/>
          <p:cNvSpPr txBox="1"/>
          <p:nvPr/>
        </p:nvSpPr>
        <p:spPr>
          <a:xfrm>
            <a:off x="11032" y="2959832"/>
            <a:ext cx="556563" cy="5078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Test</a:t>
            </a:r>
          </a:p>
          <a:p>
            <a:r>
              <a:rPr lang="en-US" altLang="ja-JP" sz="9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without</a:t>
            </a:r>
          </a:p>
          <a:p>
            <a:r>
              <a:rPr lang="en-US" altLang="ja-JP" sz="9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outliers</a:t>
            </a:r>
            <a:endParaRPr lang="ja-JP" altLang="en-US" sz="9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78" name="テキスト ボックス 77"/>
          <p:cNvSpPr txBox="1"/>
          <p:nvPr/>
        </p:nvSpPr>
        <p:spPr>
          <a:xfrm>
            <a:off x="6096" y="4587019"/>
            <a:ext cx="60144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Training</a:t>
            </a:r>
            <a:endParaRPr lang="ja-JP" altLang="en-US" sz="9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80" name="テキスト ボックス 79"/>
          <p:cNvSpPr txBox="1"/>
          <p:nvPr/>
        </p:nvSpPr>
        <p:spPr>
          <a:xfrm>
            <a:off x="167574" y="188528"/>
            <a:ext cx="250741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Supplementary Figure 6</a:t>
            </a:r>
          </a:p>
          <a:p>
            <a:r>
              <a:rPr lang="en-US" altLang="ja-JP" sz="10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Scatter plots of true and predicted scores</a:t>
            </a:r>
            <a:endParaRPr lang="ja-JP" altLang="en-US" sz="1000" dirty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52" name="テキスト ボックス 51"/>
          <p:cNvSpPr txBox="1"/>
          <p:nvPr/>
        </p:nvSpPr>
        <p:spPr>
          <a:xfrm>
            <a:off x="5233002" y="1380989"/>
            <a:ext cx="5501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900" dirty="0" smtClean="0">
                <a:solidFill>
                  <a:srgbClr val="1414FE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0.063</a:t>
            </a:r>
          </a:p>
          <a:p>
            <a:pPr algn="ctr"/>
            <a:r>
              <a:rPr kumimoji="1" lang="en-US" altLang="ja-JP" sz="900" dirty="0" smtClean="0">
                <a:solidFill>
                  <a:srgbClr val="1414FE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(0.057)</a:t>
            </a:r>
            <a:endParaRPr kumimoji="1" lang="ja-JP" altLang="en-US" sz="900" dirty="0">
              <a:solidFill>
                <a:srgbClr val="1414FE"/>
              </a:solidFill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55" name="テキスト ボックス 54"/>
          <p:cNvSpPr txBox="1"/>
          <p:nvPr/>
        </p:nvSpPr>
        <p:spPr>
          <a:xfrm>
            <a:off x="6568112" y="1403657"/>
            <a:ext cx="5501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900" smtClean="0">
                <a:solidFill>
                  <a:srgbClr val="1414FE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0.050</a:t>
            </a:r>
            <a:endParaRPr lang="en-US" altLang="ja-JP" sz="900" dirty="0" smtClean="0">
              <a:solidFill>
                <a:srgbClr val="1414FE"/>
              </a:solidFill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  <a:p>
            <a:pPr algn="ctr"/>
            <a:r>
              <a:rPr kumimoji="1" lang="en-US" altLang="ja-JP" sz="900" dirty="0" smtClean="0">
                <a:solidFill>
                  <a:srgbClr val="1414FE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(0.055)</a:t>
            </a:r>
            <a:endParaRPr kumimoji="1" lang="ja-JP" altLang="en-US" sz="900" dirty="0">
              <a:solidFill>
                <a:srgbClr val="1414FE"/>
              </a:solidFill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58" name="テキスト ボックス 57"/>
          <p:cNvSpPr txBox="1"/>
          <p:nvPr/>
        </p:nvSpPr>
        <p:spPr>
          <a:xfrm>
            <a:off x="7868220" y="1403657"/>
            <a:ext cx="5501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900" dirty="0" smtClean="0">
                <a:solidFill>
                  <a:srgbClr val="1414FE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0.050</a:t>
            </a:r>
          </a:p>
          <a:p>
            <a:pPr algn="ctr"/>
            <a:r>
              <a:rPr kumimoji="1" lang="en-US" altLang="ja-JP" sz="900" dirty="0" smtClean="0">
                <a:solidFill>
                  <a:srgbClr val="1414FE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(0.033)</a:t>
            </a:r>
            <a:endParaRPr kumimoji="1" lang="ja-JP" altLang="en-US" sz="900" dirty="0">
              <a:solidFill>
                <a:srgbClr val="1414FE"/>
              </a:solidFill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61" name="テキスト ボックス 60"/>
          <p:cNvSpPr txBox="1"/>
          <p:nvPr/>
        </p:nvSpPr>
        <p:spPr>
          <a:xfrm>
            <a:off x="1466531" y="2635444"/>
            <a:ext cx="5501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900" dirty="0" smtClean="0">
                <a:solidFill>
                  <a:srgbClr val="1414FE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0.589</a:t>
            </a:r>
          </a:p>
          <a:p>
            <a:pPr algn="ctr"/>
            <a:r>
              <a:rPr kumimoji="1" lang="en-US" altLang="ja-JP" sz="900" dirty="0" smtClean="0">
                <a:solidFill>
                  <a:srgbClr val="1414FE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(0.161)</a:t>
            </a:r>
            <a:endParaRPr kumimoji="1" lang="ja-JP" altLang="en-US" sz="900" dirty="0">
              <a:solidFill>
                <a:srgbClr val="1414FE"/>
              </a:solidFill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64" name="テキスト ボックス 63"/>
          <p:cNvSpPr txBox="1"/>
          <p:nvPr/>
        </p:nvSpPr>
        <p:spPr>
          <a:xfrm>
            <a:off x="2801259" y="2945841"/>
            <a:ext cx="5501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900" dirty="0" smtClean="0">
                <a:solidFill>
                  <a:srgbClr val="1414FE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0.112</a:t>
            </a:r>
          </a:p>
          <a:p>
            <a:pPr algn="ctr"/>
            <a:r>
              <a:rPr kumimoji="1" lang="en-US" altLang="ja-JP" sz="900" dirty="0" smtClean="0">
                <a:solidFill>
                  <a:srgbClr val="1414FE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(0.045)</a:t>
            </a:r>
            <a:endParaRPr kumimoji="1" lang="ja-JP" altLang="en-US" sz="900" dirty="0">
              <a:solidFill>
                <a:srgbClr val="1414FE"/>
              </a:solidFill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67" name="テキスト ボックス 66"/>
          <p:cNvSpPr txBox="1"/>
          <p:nvPr/>
        </p:nvSpPr>
        <p:spPr>
          <a:xfrm>
            <a:off x="3985831" y="2798249"/>
            <a:ext cx="5501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900" dirty="0" smtClean="0">
                <a:solidFill>
                  <a:srgbClr val="1414FE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0.351</a:t>
            </a:r>
          </a:p>
          <a:p>
            <a:pPr algn="ctr"/>
            <a:r>
              <a:rPr kumimoji="1" lang="en-US" altLang="ja-JP" sz="900" dirty="0" smtClean="0">
                <a:solidFill>
                  <a:srgbClr val="1414FE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(0.130)</a:t>
            </a:r>
            <a:endParaRPr kumimoji="1" lang="ja-JP" altLang="en-US" sz="900" dirty="0">
              <a:solidFill>
                <a:srgbClr val="1414FE"/>
              </a:solidFill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70" name="テキスト ボックス 69"/>
          <p:cNvSpPr txBox="1"/>
          <p:nvPr/>
        </p:nvSpPr>
        <p:spPr>
          <a:xfrm>
            <a:off x="5232397" y="2798249"/>
            <a:ext cx="5501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900" dirty="0" smtClean="0">
                <a:solidFill>
                  <a:srgbClr val="1414FE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0.332</a:t>
            </a:r>
          </a:p>
          <a:p>
            <a:pPr algn="ctr"/>
            <a:r>
              <a:rPr kumimoji="1" lang="en-US" altLang="ja-JP" sz="900" dirty="0" smtClean="0">
                <a:solidFill>
                  <a:srgbClr val="1414FE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(0.125)</a:t>
            </a:r>
            <a:endParaRPr kumimoji="1" lang="ja-JP" altLang="en-US" sz="900" dirty="0">
              <a:solidFill>
                <a:srgbClr val="1414FE"/>
              </a:solidFill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73" name="テキスト ボックス 72"/>
          <p:cNvSpPr txBox="1"/>
          <p:nvPr/>
        </p:nvSpPr>
        <p:spPr>
          <a:xfrm>
            <a:off x="6587391" y="2911875"/>
            <a:ext cx="5501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900" dirty="0" smtClean="0">
                <a:solidFill>
                  <a:srgbClr val="1414FE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0.152</a:t>
            </a:r>
          </a:p>
          <a:p>
            <a:pPr algn="ctr"/>
            <a:r>
              <a:rPr kumimoji="1" lang="en-US" altLang="ja-JP" sz="900" dirty="0" smtClean="0">
                <a:solidFill>
                  <a:srgbClr val="1414FE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(0.055)</a:t>
            </a:r>
            <a:endParaRPr kumimoji="1" lang="ja-JP" altLang="en-US" sz="900" dirty="0">
              <a:solidFill>
                <a:srgbClr val="1414FE"/>
              </a:solidFill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74" name="テキスト ボックス 73"/>
          <p:cNvSpPr txBox="1"/>
          <p:nvPr/>
        </p:nvSpPr>
        <p:spPr>
          <a:xfrm>
            <a:off x="7836367" y="2941927"/>
            <a:ext cx="5501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900" dirty="0" smtClean="0">
                <a:solidFill>
                  <a:srgbClr val="1414FE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0.056</a:t>
            </a:r>
          </a:p>
          <a:p>
            <a:pPr algn="ctr"/>
            <a:r>
              <a:rPr kumimoji="1" lang="en-US" altLang="ja-JP" sz="900" dirty="0" smtClean="0">
                <a:solidFill>
                  <a:srgbClr val="1414FE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(0.033)</a:t>
            </a:r>
            <a:endParaRPr kumimoji="1" lang="ja-JP" altLang="en-US" sz="900" dirty="0">
              <a:solidFill>
                <a:srgbClr val="1414FE"/>
              </a:solidFill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81" name="テキスト ボックス 80"/>
          <p:cNvSpPr txBox="1"/>
          <p:nvPr/>
        </p:nvSpPr>
        <p:spPr>
          <a:xfrm>
            <a:off x="1457964" y="4560493"/>
            <a:ext cx="5501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900" dirty="0" smtClean="0">
                <a:solidFill>
                  <a:srgbClr val="0000FF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1.001</a:t>
            </a:r>
          </a:p>
          <a:p>
            <a:pPr algn="ctr"/>
            <a:r>
              <a:rPr kumimoji="1" lang="en-US" altLang="ja-JP" sz="900" dirty="0" smtClean="0">
                <a:solidFill>
                  <a:srgbClr val="0000FF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(0.055)</a:t>
            </a:r>
            <a:endParaRPr kumimoji="1" lang="ja-JP" altLang="en-US" sz="900" dirty="0">
              <a:solidFill>
                <a:srgbClr val="0000FF"/>
              </a:solidFill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82" name="テキスト ボックス 81"/>
          <p:cNvSpPr txBox="1"/>
          <p:nvPr/>
        </p:nvSpPr>
        <p:spPr>
          <a:xfrm>
            <a:off x="2753116" y="4675909"/>
            <a:ext cx="5501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900" dirty="0" smtClean="0">
                <a:solidFill>
                  <a:srgbClr val="0000FF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1.000</a:t>
            </a:r>
          </a:p>
          <a:p>
            <a:pPr algn="ctr"/>
            <a:r>
              <a:rPr kumimoji="1" lang="en-US" altLang="ja-JP" sz="900" dirty="0" smtClean="0">
                <a:solidFill>
                  <a:srgbClr val="0000FF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(0.006)</a:t>
            </a:r>
            <a:endParaRPr kumimoji="1" lang="ja-JP" altLang="en-US" sz="900" dirty="0">
              <a:solidFill>
                <a:srgbClr val="0000FF"/>
              </a:solidFill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83" name="テキスト ボックス 82"/>
          <p:cNvSpPr txBox="1"/>
          <p:nvPr/>
        </p:nvSpPr>
        <p:spPr>
          <a:xfrm>
            <a:off x="3980894" y="4675909"/>
            <a:ext cx="5501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900" dirty="0" smtClean="0">
                <a:solidFill>
                  <a:srgbClr val="0000FF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0.959</a:t>
            </a:r>
          </a:p>
          <a:p>
            <a:pPr algn="ctr"/>
            <a:r>
              <a:rPr kumimoji="1" lang="en-US" altLang="ja-JP" sz="900" dirty="0" smtClean="0">
                <a:solidFill>
                  <a:srgbClr val="0000FF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(0.004)</a:t>
            </a:r>
            <a:endParaRPr kumimoji="1" lang="ja-JP" altLang="en-US" sz="900" dirty="0">
              <a:solidFill>
                <a:srgbClr val="0000FF"/>
              </a:solidFill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84" name="テキスト ボックス 83"/>
          <p:cNvSpPr txBox="1"/>
          <p:nvPr/>
        </p:nvSpPr>
        <p:spPr>
          <a:xfrm>
            <a:off x="5231026" y="4645061"/>
            <a:ext cx="5501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900" dirty="0" smtClean="0">
                <a:solidFill>
                  <a:srgbClr val="0000FF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1.000</a:t>
            </a:r>
          </a:p>
          <a:p>
            <a:pPr algn="ctr"/>
            <a:r>
              <a:rPr kumimoji="1" lang="en-US" altLang="ja-JP" sz="900" dirty="0" smtClean="0">
                <a:solidFill>
                  <a:srgbClr val="0000FF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(0.005)</a:t>
            </a:r>
            <a:endParaRPr kumimoji="1" lang="ja-JP" altLang="en-US" sz="900" dirty="0">
              <a:solidFill>
                <a:srgbClr val="0000FF"/>
              </a:solidFill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85" name="テキスト ボックス 84"/>
          <p:cNvSpPr txBox="1"/>
          <p:nvPr/>
        </p:nvSpPr>
        <p:spPr>
          <a:xfrm>
            <a:off x="6539158" y="4678902"/>
            <a:ext cx="5501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900" dirty="0" smtClean="0">
                <a:solidFill>
                  <a:srgbClr val="0000FF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1.000</a:t>
            </a:r>
          </a:p>
          <a:p>
            <a:pPr algn="ctr"/>
            <a:r>
              <a:rPr kumimoji="1" lang="en-US" altLang="ja-JP" sz="900" dirty="0" smtClean="0">
                <a:solidFill>
                  <a:srgbClr val="0000FF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(0.005)</a:t>
            </a:r>
            <a:endParaRPr kumimoji="1" lang="ja-JP" altLang="en-US" sz="900" dirty="0">
              <a:solidFill>
                <a:srgbClr val="0000FF"/>
              </a:solidFill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86" name="テキスト ボックス 85"/>
          <p:cNvSpPr txBox="1"/>
          <p:nvPr/>
        </p:nvSpPr>
        <p:spPr>
          <a:xfrm>
            <a:off x="7831431" y="4724319"/>
            <a:ext cx="5501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900" dirty="0" smtClean="0">
                <a:solidFill>
                  <a:srgbClr val="0000FF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1.032</a:t>
            </a:r>
          </a:p>
          <a:p>
            <a:pPr algn="ctr"/>
            <a:r>
              <a:rPr kumimoji="1" lang="en-US" altLang="ja-JP" sz="900" dirty="0" smtClean="0">
                <a:solidFill>
                  <a:srgbClr val="0000FF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(0.000)</a:t>
            </a:r>
            <a:endParaRPr kumimoji="1" lang="ja-JP" altLang="en-US" sz="900" dirty="0">
              <a:solidFill>
                <a:srgbClr val="0000FF"/>
              </a:solidFill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49" name="正方形/長方形 48"/>
          <p:cNvSpPr/>
          <p:nvPr/>
        </p:nvSpPr>
        <p:spPr>
          <a:xfrm>
            <a:off x="167574" y="5666755"/>
            <a:ext cx="7932965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8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The</a:t>
            </a:r>
            <a:r>
              <a:rPr lang="ja-JP" altLang="en-US" sz="8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 </a:t>
            </a:r>
            <a:r>
              <a:rPr lang="en-US" altLang="ja-JP" sz="8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blue lines and blue values are regression line and regression slope</a:t>
            </a:r>
            <a:r>
              <a:rPr lang="ja-JP" altLang="en-US" sz="800" dirty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 </a:t>
            </a:r>
            <a:r>
              <a:rPr lang="en-US" altLang="ja-JP" sz="8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(SE), respectively</a:t>
            </a:r>
            <a:r>
              <a:rPr lang="en-US" altLang="ja-JP" sz="800" dirty="0" smtClean="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.</a:t>
            </a:r>
            <a:endParaRPr lang="en-US" altLang="ja-JP" sz="800" dirty="0" smtClean="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28792770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61</TotalTime>
  <Words>112</Words>
  <Application>Microsoft Office PowerPoint</Application>
  <PresentationFormat>ユーザー設定</PresentationFormat>
  <Paragraphs>5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Arial Unicode MS</vt:lpstr>
      <vt:lpstr>ＭＳ Ｐ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akahashi yuta</dc:creator>
  <cp:lastModifiedBy>takahashi yuta</cp:lastModifiedBy>
  <cp:revision>11</cp:revision>
  <dcterms:created xsi:type="dcterms:W3CDTF">2020-03-13T06:53:28Z</dcterms:created>
  <dcterms:modified xsi:type="dcterms:W3CDTF">2020-06-25T00:51:43Z</dcterms:modified>
</cp:coreProperties>
</file>